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73" autoAdjust="0"/>
  </p:normalViewPr>
  <p:slideViewPr>
    <p:cSldViewPr>
      <p:cViewPr varScale="1">
        <p:scale>
          <a:sx n="109" d="100"/>
          <a:sy n="109" d="100"/>
        </p:scale>
        <p:origin x="-177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4BE308-CA68-4A6B-9F5C-D7E2CC05CAD1}" type="datetimeFigureOut">
              <a:rPr lang="de-DE" smtClean="0"/>
              <a:pPr/>
              <a:t>21.01.2017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E62841-697E-4FAC-93A7-F37878A783B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3586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E62841-697E-4FAC-93A7-F37878A783B3}" type="slidenum">
              <a:rPr lang="de-DE" smtClean="0"/>
              <a:pPr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9670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>
          <a:blip/>
          <a:tile sx="8004" sy="500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12"/>
          <p:cNvSpPr/>
          <p:nvPr/>
        </p:nvSpPr>
        <p:spPr>
          <a:xfrm>
            <a:off x="65315" y="69750"/>
            <a:ext cx="9013368" cy="6692200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blipFill>
            <a:blip>
              <a:alphaModFix/>
            </a:blip>
            <a:tile sx="8004" sy="500" algn="tl"/>
          </a:blip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Subtitle 8"/>
          <p:cNvSpPr txBox="1">
            <a:spLocks noGrp="1"/>
          </p:cNvSpPr>
          <p:nvPr>
            <p:ph type="subTitle" idx="1"/>
          </p:nvPr>
        </p:nvSpPr>
        <p:spPr>
          <a:xfrm>
            <a:off x="1295403" y="3200400"/>
            <a:ext cx="6400800" cy="1600200"/>
          </a:xfrm>
        </p:spPr>
        <p:txBody>
          <a:bodyPr anchorCtr="1"/>
          <a:lstStyle>
            <a:lvl1pPr marL="0" indent="0" algn="ctr">
              <a:buNone/>
              <a:defRPr>
                <a:solidFill>
                  <a:srgbClr val="696464"/>
                </a:solidFill>
              </a:defRPr>
            </a:lvl1pPr>
          </a:lstStyle>
          <a:p>
            <a:pPr lvl="0"/>
            <a:r>
              <a:rPr lang="en-US"/>
              <a:t>Click to edit Master subtitle style</a:t>
            </a:r>
          </a:p>
        </p:txBody>
      </p:sp>
      <p:sp>
        <p:nvSpPr>
          <p:cNvPr id="5" name="Date Placeholder 27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7D5F169-7250-407F-A2E4-EA0691443D84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6" name="Footer Placeholder 16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2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E511270-A0DB-4AAD-9361-1232479CF50B}" type="slidenum">
              <a:rPr/>
              <a:pPr lvl="0"/>
              <a:t>‹#›</a:t>
            </a:fld>
            <a:endParaRPr lang="de-DE"/>
          </a:p>
        </p:txBody>
      </p:sp>
      <p:sp>
        <p:nvSpPr>
          <p:cNvPr id="8" name="Rectangle 6"/>
          <p:cNvSpPr/>
          <p:nvPr/>
        </p:nvSpPr>
        <p:spPr>
          <a:xfrm>
            <a:off x="62929" y="1449305"/>
            <a:ext cx="9021534" cy="1527349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9"/>
          <p:cNvSpPr/>
          <p:nvPr/>
        </p:nvSpPr>
        <p:spPr>
          <a:xfrm>
            <a:off x="62929" y="1396718"/>
            <a:ext cx="9021534" cy="120581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Rectangle 10"/>
          <p:cNvSpPr/>
          <p:nvPr/>
        </p:nvSpPr>
        <p:spPr>
          <a:xfrm>
            <a:off x="62929" y="2976646"/>
            <a:ext cx="9021534" cy="110532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1" name="Title 7"/>
          <p:cNvSpPr txBox="1">
            <a:spLocks noGrp="1"/>
          </p:cNvSpPr>
          <p:nvPr>
            <p:ph type="ctrTitle"/>
          </p:nvPr>
        </p:nvSpPr>
        <p:spPr>
          <a:xfrm>
            <a:off x="457200" y="1505934"/>
            <a:ext cx="8229600" cy="1470026"/>
          </a:xfrm>
        </p:spPr>
        <p:txBody>
          <a:bodyPr anchor="ctr" anchorCtr="1"/>
          <a:lstStyle>
            <a:lvl1pPr algn="ctr">
              <a:defRPr>
                <a:solidFill>
                  <a:srgbClr val="FFFFFF"/>
                </a:solidFill>
              </a:defRPr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7202126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4727E3C-631C-4AB4-A0E5-C066F6EE394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CF92128-E436-40BF-8973-9F8E83BD4EFC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10012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 txBox="1">
            <a:spLocks noGrp="1"/>
          </p:cNvSpPr>
          <p:nvPr>
            <p:ph type="title" orient="vert"/>
          </p:nvPr>
        </p:nvSpPr>
        <p:spPr>
          <a:xfrm>
            <a:off x="6629400" y="274640"/>
            <a:ext cx="2011680" cy="5851529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>
          <a:xfrm>
            <a:off x="914400" y="274640"/>
            <a:ext cx="5562596" cy="5851529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60B198F-4474-4BA9-8712-189BFADE6B5D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04746E1-5A69-40C7-8C30-1AA7D0DE089F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37371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1ECE5AF-9A72-4802-AABC-CD7FD97A2EE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161E25C-BDA8-4363-884F-6D35F2C7EFD0}" type="slidenum">
              <a:rPr/>
              <a:pPr lvl="0"/>
              <a:t>‹#›</a:t>
            </a:fld>
            <a:endParaRPr lang="de-DE"/>
          </a:p>
        </p:txBody>
      </p:sp>
      <p:sp>
        <p:nvSpPr>
          <p:cNvPr id="6" name="Content Placeholder 7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9952189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blipFill>
          <a:blip/>
          <a:tile sx="8004" sy="500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0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9"/>
          <p:cNvSpPr/>
          <p:nvPr/>
        </p:nvSpPr>
        <p:spPr>
          <a:xfrm>
            <a:off x="65315" y="69750"/>
            <a:ext cx="9013368" cy="6692200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blipFill>
            <a:blip>
              <a:alphaModFix/>
            </a:blip>
            <a:tile sx="8004" sy="500" algn="tl"/>
          </a:blip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xfrm>
            <a:off x="722311" y="952503"/>
            <a:ext cx="7772400" cy="1362071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2"/>
          <p:cNvSpPr txBox="1">
            <a:spLocks noGrp="1"/>
          </p:cNvSpPr>
          <p:nvPr>
            <p:ph type="body" idx="1"/>
          </p:nvPr>
        </p:nvSpPr>
        <p:spPr>
          <a:xfrm>
            <a:off x="722311" y="2547939"/>
            <a:ext cx="7772400" cy="1338260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3C3775B-58D3-40C3-9283-85FBAF4B20AA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4"/>
          <p:cNvSpPr txBox="1">
            <a:spLocks noGrp="1"/>
          </p:cNvSpPr>
          <p:nvPr>
            <p:ph type="ftr" sz="quarter" idx="9"/>
          </p:nvPr>
        </p:nvSpPr>
        <p:spPr>
          <a:xfrm>
            <a:off x="800100" y="6172200"/>
            <a:ext cx="4000500" cy="457200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8" name="Rectangle 6"/>
          <p:cNvSpPr/>
          <p:nvPr/>
        </p:nvSpPr>
        <p:spPr>
          <a:xfrm flipV="1">
            <a:off x="69412" y="2376827"/>
            <a:ext cx="9013515" cy="91440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7"/>
          <p:cNvSpPr/>
          <p:nvPr/>
        </p:nvSpPr>
        <p:spPr>
          <a:xfrm>
            <a:off x="69146" y="2341476"/>
            <a:ext cx="9013780" cy="45720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Rectangle 8"/>
          <p:cNvSpPr/>
          <p:nvPr/>
        </p:nvSpPr>
        <p:spPr>
          <a:xfrm>
            <a:off x="68305" y="2468880"/>
            <a:ext cx="9014621" cy="45720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1" name="Slide Number Placeholder 5"/>
          <p:cNvSpPr txBox="1">
            <a:spLocks noGrp="1"/>
          </p:cNvSpPr>
          <p:nvPr>
            <p:ph type="sldNum" sz="quarter" idx="8"/>
          </p:nvPr>
        </p:nvSpPr>
        <p:spPr>
          <a:xfrm>
            <a:off x="146304" y="6208776"/>
            <a:ext cx="457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fld id="{F890AC72-C3E8-4D3D-982D-A8E7A1AC8729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39227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1300614-3240-4435-87DE-31274C0B51D8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EB5FD13-67B2-481D-B1BB-2DB515FB124E}" type="slidenum">
              <a:rPr/>
              <a:pPr lvl="0"/>
              <a:t>‹#›</a:t>
            </a:fld>
            <a:endParaRPr lang="de-DE"/>
          </a:p>
        </p:txBody>
      </p:sp>
      <p:sp>
        <p:nvSpPr>
          <p:cNvPr id="6" name="Content Placeholder 8"/>
          <p:cNvSpPr txBox="1">
            <a:spLocks noGrp="1"/>
          </p:cNvSpPr>
          <p:nvPr>
            <p:ph idx="1"/>
          </p:nvPr>
        </p:nvSpPr>
        <p:spPr>
          <a:xfrm>
            <a:off x="914400" y="1447796"/>
            <a:ext cx="3749039" cy="4572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Content Placeholder 10"/>
          <p:cNvSpPr txBox="1">
            <a:spLocks noGrp="1"/>
          </p:cNvSpPr>
          <p:nvPr>
            <p:ph idx="2"/>
          </p:nvPr>
        </p:nvSpPr>
        <p:spPr>
          <a:xfrm>
            <a:off x="4933946" y="1447796"/>
            <a:ext cx="3749039" cy="4572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065455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914400" y="273048"/>
            <a:ext cx="7772400" cy="1143000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914400" y="1447796"/>
            <a:ext cx="3733796" cy="761996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D34817"/>
                </a:solidFill>
                <a:latin typeface="Franklin Gothic Book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3"/>
          </p:nvPr>
        </p:nvSpPr>
        <p:spPr>
          <a:xfrm>
            <a:off x="4953003" y="1447796"/>
            <a:ext cx="3733796" cy="761996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D34817"/>
                </a:solidFill>
                <a:latin typeface="Franklin Gothic Book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088F3A7-F488-4862-91B3-99FE4BB230D2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6" name="Footer Placeholder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52A46C0-9D38-42CB-8A5E-467504A116F8}" type="slidenum">
              <a:rPr/>
              <a:pPr lvl="0"/>
              <a:t>‹#›</a:t>
            </a:fld>
            <a:endParaRPr lang="de-DE"/>
          </a:p>
        </p:txBody>
      </p:sp>
      <p:sp>
        <p:nvSpPr>
          <p:cNvPr id="8" name="Content Placeholder 10"/>
          <p:cNvSpPr txBox="1">
            <a:spLocks noGrp="1"/>
          </p:cNvSpPr>
          <p:nvPr>
            <p:ph idx="2"/>
          </p:nvPr>
        </p:nvSpPr>
        <p:spPr>
          <a:xfrm>
            <a:off x="914400" y="2247896"/>
            <a:ext cx="3733796" cy="38862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9" name="Content Placeholder 12"/>
          <p:cNvSpPr txBox="1">
            <a:spLocks noGrp="1"/>
          </p:cNvSpPr>
          <p:nvPr>
            <p:ph idx="4"/>
          </p:nvPr>
        </p:nvSpPr>
        <p:spPr>
          <a:xfrm>
            <a:off x="4953003" y="2247896"/>
            <a:ext cx="3733796" cy="38862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228562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142A67C-F73A-4B77-B103-94E0DFACC5A6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1176507-1D35-4C1D-8B92-25C07D15E817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30832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975BEF2-B91B-493A-8CB9-8A48C6B0EBA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3" name="Footer Placeholder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4" name="Slide Number Placehold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39B3995-1CF2-4A8D-88A6-0A28FB4C29AC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37179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8"/>
          <p:cNvSpPr/>
          <p:nvPr/>
        </p:nvSpPr>
        <p:spPr>
          <a:xfrm>
            <a:off x="64008" y="69750"/>
            <a:ext cx="9013368" cy="6693407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solidFill>
            <a:srgbClr val="FFFFFF"/>
          </a:solid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xfrm>
            <a:off x="914400" y="273048"/>
            <a:ext cx="7772400" cy="1143000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2"/>
          <p:cNvSpPr txBox="1">
            <a:spLocks noGrp="1"/>
          </p:cNvSpPr>
          <p:nvPr>
            <p:ph type="body" idx="2"/>
          </p:nvPr>
        </p:nvSpPr>
        <p:spPr>
          <a:xfrm>
            <a:off x="914400" y="1600200"/>
            <a:ext cx="1904996" cy="4495803"/>
          </a:xfrm>
        </p:spPr>
        <p:txBody>
          <a:bodyPr/>
          <a:lstStyle>
            <a:lvl1pPr marL="0" indent="0">
              <a:buNone/>
              <a:defRPr sz="18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9DAA5AD-1C2C-486D-9CAD-7395A1E6D2BD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8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75EEFF6-E812-4D8B-A4B9-C917E2F842A5}" type="slidenum">
              <a:rPr/>
              <a:pPr lvl="0"/>
              <a:t>‹#›</a:t>
            </a:fld>
            <a:endParaRPr lang="de-DE"/>
          </a:p>
        </p:txBody>
      </p:sp>
      <p:sp>
        <p:nvSpPr>
          <p:cNvPr id="9" name="Content Placeholder 10"/>
          <p:cNvSpPr txBox="1">
            <a:spLocks noGrp="1"/>
          </p:cNvSpPr>
          <p:nvPr>
            <p:ph idx="1"/>
          </p:nvPr>
        </p:nvSpPr>
        <p:spPr>
          <a:xfrm>
            <a:off x="2971800" y="1600200"/>
            <a:ext cx="5715000" cy="449580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092500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914400" y="4900553"/>
            <a:ext cx="7315200" cy="522286"/>
          </a:xfrm>
        </p:spPr>
        <p:txBody>
          <a:bodyPr anchor="ctr"/>
          <a:lstStyle>
            <a:lvl1pPr>
              <a:defRPr sz="28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3"/>
          <p:cNvSpPr txBox="1">
            <a:spLocks noGrp="1"/>
          </p:cNvSpPr>
          <p:nvPr>
            <p:ph type="body" idx="2"/>
          </p:nvPr>
        </p:nvSpPr>
        <p:spPr>
          <a:xfrm>
            <a:off x="914400" y="5445828"/>
            <a:ext cx="7315200" cy="685800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9B525EE-84EC-4CEF-A8B2-81B0386111AC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5"/>
          <p:cNvSpPr txBox="1">
            <a:spLocks noGrp="1"/>
          </p:cNvSpPr>
          <p:nvPr>
            <p:ph type="ftr" sz="quarter" idx="9"/>
          </p:nvPr>
        </p:nvSpPr>
        <p:spPr>
          <a:xfrm>
            <a:off x="914400" y="6172200"/>
            <a:ext cx="3886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6"/>
          <p:cNvSpPr txBox="1">
            <a:spLocks noGrp="1"/>
          </p:cNvSpPr>
          <p:nvPr>
            <p:ph type="sldNum" sz="quarter" idx="8"/>
          </p:nvPr>
        </p:nvSpPr>
        <p:spPr>
          <a:xfrm>
            <a:off x="146304" y="6208776"/>
            <a:ext cx="457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fld id="{61174793-849C-47D2-9E54-11ABA43941CE}" type="slidenum">
              <a:rPr/>
              <a:pPr lvl="0"/>
              <a:t>‹#›</a:t>
            </a:fld>
            <a:endParaRPr lang="de-DE"/>
          </a:p>
        </p:txBody>
      </p:sp>
      <p:sp>
        <p:nvSpPr>
          <p:cNvPr id="7" name="Rectangle 10"/>
          <p:cNvSpPr/>
          <p:nvPr/>
        </p:nvSpPr>
        <p:spPr>
          <a:xfrm flipV="1">
            <a:off x="68305" y="4683556"/>
            <a:ext cx="9006840" cy="91440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8" name="Rectangle 11"/>
          <p:cNvSpPr/>
          <p:nvPr/>
        </p:nvSpPr>
        <p:spPr>
          <a:xfrm>
            <a:off x="68506" y="4650473"/>
            <a:ext cx="9006638" cy="45720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12"/>
          <p:cNvSpPr/>
          <p:nvPr/>
        </p:nvSpPr>
        <p:spPr>
          <a:xfrm>
            <a:off x="68506" y="4773222"/>
            <a:ext cx="9006638" cy="48810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Picture Placeholder 2"/>
          <p:cNvSpPr txBox="1">
            <a:spLocks noGrp="1"/>
          </p:cNvSpPr>
          <p:nvPr>
            <p:ph type="pic" idx="1"/>
          </p:nvPr>
        </p:nvSpPr>
        <p:spPr>
          <a:xfrm>
            <a:off x="68305" y="66678"/>
            <a:ext cx="9001874" cy="4581528"/>
          </a:xfrm>
          <a:solidFill>
            <a:srgbClr val="E9E5DC"/>
          </a:solidFill>
          <a:ln w="6345">
            <a:solidFill>
              <a:srgbClr val="000000"/>
            </a:solidFill>
            <a:prstDash val="solid"/>
          </a:ln>
        </p:spPr>
        <p:txBody>
          <a:bodyPr/>
          <a:lstStyle>
            <a:lvl1pPr marL="0" indent="0">
              <a:buNone/>
              <a:defRPr sz="3200"/>
            </a:lvl1pPr>
          </a:lstStyle>
          <a:p>
            <a:pPr lvl="0"/>
            <a:r>
              <a:rPr lang="en-US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30482912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8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7"/>
          <p:cNvSpPr/>
          <p:nvPr/>
        </p:nvSpPr>
        <p:spPr>
          <a:xfrm>
            <a:off x="64008" y="69750"/>
            <a:ext cx="9013368" cy="6693407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solidFill>
            <a:srgbClr val="FFFFFF"/>
          </a:solid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Placeholder 21"/>
          <p:cNvSpPr txBox="1">
            <a:spLocks noGrp="1"/>
          </p:cNvSpPr>
          <p:nvPr>
            <p:ph type="title"/>
          </p:nvPr>
        </p:nvSpPr>
        <p:spPr>
          <a:xfrm>
            <a:off x="914400" y="274640"/>
            <a:ext cx="7772400" cy="11430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91440" anchor="b" anchorCtr="0" compatLnSpc="1"/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12"/>
          <p:cNvSpPr txBox="1">
            <a:spLocks noGrp="1"/>
          </p:cNvSpPr>
          <p:nvPr>
            <p:ph type="body" idx="1"/>
          </p:nvPr>
        </p:nvSpPr>
        <p:spPr>
          <a:xfrm>
            <a:off x="914400" y="1447796"/>
            <a:ext cx="7772400" cy="45720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Date Placeholder 13"/>
          <p:cNvSpPr txBox="1">
            <a:spLocks noGrp="1"/>
          </p:cNvSpPr>
          <p:nvPr>
            <p:ph type="dt" sz="half" idx="2"/>
          </p:nvPr>
        </p:nvSpPr>
        <p:spPr>
          <a:xfrm>
            <a:off x="6172200" y="6191246"/>
            <a:ext cx="2476496" cy="47624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696464"/>
                </a:solidFill>
                <a:uFillTx/>
                <a:latin typeface="Perpetua"/>
              </a:defRPr>
            </a:lvl1pPr>
          </a:lstStyle>
          <a:p>
            <a:pPr lvl="0"/>
            <a:fld id="{B7C87843-29A8-4B27-9A56-528D4759A020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2"/>
          <p:cNvSpPr txBox="1">
            <a:spLocks noGrp="1"/>
          </p:cNvSpPr>
          <p:nvPr>
            <p:ph type="ftr" sz="quarter" idx="3"/>
          </p:nvPr>
        </p:nvSpPr>
        <p:spPr>
          <a:xfrm>
            <a:off x="914400" y="6172200"/>
            <a:ext cx="3962396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696464"/>
                </a:solidFill>
                <a:uFillTx/>
                <a:latin typeface="Perpetua"/>
              </a:defRPr>
            </a:lvl1pPr>
          </a:lstStyle>
          <a:p>
            <a:pPr lvl="0"/>
            <a:endParaRPr lang="de-DE"/>
          </a:p>
        </p:txBody>
      </p:sp>
      <p:sp>
        <p:nvSpPr>
          <p:cNvPr id="8" name="Slide Number Placeholder 22"/>
          <p:cNvSpPr txBox="1">
            <a:spLocks noGrp="1"/>
          </p:cNvSpPr>
          <p:nvPr>
            <p:ph type="sldNum" sz="quarter" idx="4"/>
          </p:nvPr>
        </p:nvSpPr>
        <p:spPr>
          <a:xfrm>
            <a:off x="146304" y="6210303"/>
            <a:ext cx="457200" cy="457200"/>
          </a:xfrm>
          <a:prstGeom prst="rect">
            <a:avLst/>
          </a:prstGeom>
          <a:solidFill>
            <a:srgbClr val="D34817"/>
          </a:solidFill>
          <a:ln>
            <a:noFill/>
          </a:ln>
        </p:spPr>
        <p:txBody>
          <a:bodyPr vert="horz" wrap="none" lIns="0" tIns="0" rIns="0" bIns="0" anchor="ctr" anchorCtr="1" compatLnSpc="1"/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FFFFFF"/>
                </a:solidFill>
                <a:uFillTx/>
                <a:latin typeface="Franklin Gothic Book"/>
              </a:defRPr>
            </a:lvl1pPr>
          </a:lstStyle>
          <a:p>
            <a:pPr lvl="0"/>
            <a:fld id="{32BDC93F-0C38-439E-9C7B-0A2D23B61AB3}" type="slidenum">
              <a:rPr/>
              <a:pPr lvl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marL="0" marR="0" lvl="0" indent="0" algn="l" defTabSz="914400" rtl="0" fontAlgn="auto" hangingPunct="1">
        <a:lnSpc>
          <a:spcPct val="100000"/>
        </a:lnSpc>
        <a:spcBef>
          <a:spcPts val="0"/>
        </a:spcBef>
        <a:spcAft>
          <a:spcPts val="0"/>
        </a:spcAft>
        <a:buNone/>
        <a:tabLst/>
        <a:defRPr lang="en-US" sz="4000" b="0" i="0" u="none" strike="noStrike" kern="1200" cap="none" spc="0" baseline="0">
          <a:solidFill>
            <a:srgbClr val="696464"/>
          </a:solidFill>
          <a:uFillTx/>
          <a:latin typeface="Franklin Gothic Book"/>
        </a:defRPr>
      </a:lvl1pPr>
    </p:titleStyle>
    <p:bodyStyle>
      <a:lvl1pPr marL="274320" marR="0" lvl="0" indent="-274320" algn="l" defTabSz="914400" rtl="0" fontAlgn="auto" hangingPunct="1">
        <a:lnSpc>
          <a:spcPct val="100000"/>
        </a:lnSpc>
        <a:spcBef>
          <a:spcPts val="580"/>
        </a:spcBef>
        <a:spcAft>
          <a:spcPts val="0"/>
        </a:spcAft>
        <a:buClr>
          <a:srgbClr val="D34817"/>
        </a:buClr>
        <a:buSzPct val="85000"/>
        <a:buFont typeface="Wingdings 2"/>
        <a:buChar char=""/>
        <a:tabLst/>
        <a:defRPr lang="en-US" sz="2600" b="0" i="0" u="none" strike="noStrike" kern="1200" cap="none" spc="0" baseline="0">
          <a:solidFill>
            <a:srgbClr val="000000"/>
          </a:solidFill>
          <a:uFillTx/>
          <a:latin typeface="Perpetua"/>
        </a:defRPr>
      </a:lvl1pPr>
      <a:lvl2pPr marL="548640" marR="0" lvl="1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9B2D1F"/>
        </a:buClr>
        <a:buSzPct val="85000"/>
        <a:buFont typeface="Wingdings 2"/>
        <a:buChar char="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Perpetua"/>
        </a:defRPr>
      </a:lvl2pPr>
      <a:lvl3pPr marL="822960" marR="0" lvl="2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E6B1AB"/>
        </a:buClr>
        <a:buSzPct val="85000"/>
        <a:buFont typeface="Wingdings 2"/>
        <a:buChar char="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3pPr>
      <a:lvl4pPr marL="1097280" marR="0" lvl="3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A28E6A"/>
        </a:buClr>
        <a:buSzPct val="80000"/>
        <a:buFont typeface="Wingdings 2"/>
        <a:buChar char="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4pPr>
      <a:lvl5pPr marL="1371600" marR="0" lvl="4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A28E6A"/>
        </a:buClr>
        <a:buSzPct val="100000"/>
        <a:buChar char="o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5pPr>
    </p:bodyStyle>
    <p:otherStyle/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0288" y="3201707"/>
            <a:ext cx="2097161" cy="27339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4249" y="857545"/>
            <a:ext cx="2133601" cy="21809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4050" y="811625"/>
            <a:ext cx="2236440" cy="22378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754" y="811625"/>
            <a:ext cx="2254695" cy="23762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1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2989" y="811625"/>
            <a:ext cx="2001080" cy="2355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110" y="3180737"/>
            <a:ext cx="2196900" cy="2602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4087" y="3125708"/>
            <a:ext cx="2372362" cy="28861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4050" y="3195955"/>
            <a:ext cx="2367335" cy="258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 rot="16200000">
            <a:off x="1675353" y="1605181"/>
            <a:ext cx="180305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Lineage</a:t>
            </a:r>
            <a:endParaRPr lang="de-DE" sz="1400" dirty="0"/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2125649" y="1960240"/>
            <a:ext cx="30623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6099435" y="1605180"/>
            <a:ext cx="180305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CD11b</a:t>
            </a:r>
            <a:endParaRPr lang="de-DE" sz="1400" dirty="0"/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6621449" y="1914751"/>
            <a:ext cx="30623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rot="10800000" flipV="1">
            <a:off x="1248221" y="2735248"/>
            <a:ext cx="1791829" cy="460707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4030649" y="2735249"/>
            <a:ext cx="914400" cy="42306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 rot="16200000">
            <a:off x="3766346" y="1608201"/>
            <a:ext cx="190093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HLA-DR</a:t>
            </a:r>
            <a:endParaRPr lang="de-DE" sz="14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-652066" y="4165029"/>
            <a:ext cx="216880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         CD14</a:t>
            </a:r>
            <a:endParaRPr lang="de-DE" sz="14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3775554" y="4171441"/>
            <a:ext cx="196097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       CD15</a:t>
            </a:r>
            <a:endParaRPr lang="de-DE" sz="14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1460346" y="4165030"/>
            <a:ext cx="216880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         HLA-DR</a:t>
            </a:r>
            <a:endParaRPr lang="de-DE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3323776" y="5704072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CD11b</a:t>
            </a:r>
            <a:endParaRPr lang="de-DE" sz="14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6020476" y="4171442"/>
            <a:ext cx="196096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       CD124</a:t>
            </a:r>
            <a:endParaRPr lang="de-DE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7688249" y="5704071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CD15</a:t>
            </a:r>
            <a:endParaRPr lang="de-DE" sz="1400" dirty="0"/>
          </a:p>
        </p:txBody>
      </p:sp>
      <p:sp>
        <p:nvSpPr>
          <p:cNvPr id="43" name="TextBox 42"/>
          <p:cNvSpPr txBox="1"/>
          <p:nvPr/>
        </p:nvSpPr>
        <p:spPr>
          <a:xfrm>
            <a:off x="7647453" y="2815000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CD33</a:t>
            </a:r>
            <a:endParaRPr lang="de-DE" sz="14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-554984" y="1644640"/>
            <a:ext cx="188196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             CD45</a:t>
            </a:r>
            <a:endParaRPr lang="de-DE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3856732" y="144449"/>
            <a:ext cx="167840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00" dirty="0" smtClean="0"/>
              <a:t>Myeloid cells</a:t>
            </a:r>
            <a:endParaRPr lang="de-DE" sz="2200" dirty="0"/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2125649" y="4336323"/>
            <a:ext cx="30623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6620010" y="4367389"/>
            <a:ext cx="30623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4266869" y="1973249"/>
            <a:ext cx="30623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560263" y="2831832"/>
            <a:ext cx="441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FSC</a:t>
            </a:r>
            <a:endParaRPr lang="de-DE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5664069" y="5630601"/>
            <a:ext cx="441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FSC</a:t>
            </a:r>
            <a:endParaRPr lang="de-DE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1232981" y="5630601"/>
            <a:ext cx="441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FSC</a:t>
            </a:r>
            <a:endParaRPr lang="de-DE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3294776" y="2802740"/>
            <a:ext cx="441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FSC</a:t>
            </a:r>
            <a:endParaRPr lang="de-DE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974115" y="2808472"/>
            <a:ext cx="441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FSC</a:t>
            </a:r>
            <a:endParaRPr lang="de-DE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1280736" y="6292796"/>
            <a:ext cx="7329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dditional File 4</a:t>
            </a:r>
            <a:r>
              <a:rPr lang="de-DE" sz="1200" dirty="0" smtClean="0"/>
              <a:t>. Gating strategy used to identify myeloid cells including myeloid-derived </a:t>
            </a:r>
            <a:r>
              <a:rPr lang="de-DE" sz="1200" smtClean="0"/>
              <a:t>suppressor </a:t>
            </a:r>
            <a:r>
              <a:rPr lang="de-DE" sz="1200" smtClean="0"/>
              <a:t>cells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2101097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quity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quity</Template>
  <TotalTime>49</TotalTime>
  <Words>43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Equity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TI Group Seminar</dc:title>
  <dc:creator>Jithendra</dc:creator>
  <cp:lastModifiedBy>Christopher Shipp</cp:lastModifiedBy>
  <cp:revision>143</cp:revision>
  <dcterms:created xsi:type="dcterms:W3CDTF">2013-02-19T11:11:27Z</dcterms:created>
  <dcterms:modified xsi:type="dcterms:W3CDTF">2017-01-21T15:25:51Z</dcterms:modified>
</cp:coreProperties>
</file>